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216650" cy="8686800"/>
  <p:notesSz cx="5943600" cy="82296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1E7641-7D23-43C1-93DD-07FDE423FD2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55962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10680" y="5021640"/>
            <a:ext cx="55962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CA6ACC-AE48-418B-9846-F619D53167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106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1780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5FFF07-6016-44CB-9360-54A6A92D763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202840" y="202716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095360" y="202716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10680" y="502164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202840" y="502164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095360" y="502164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110E96-74FC-4D1A-A9B5-7A18BE31996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10680" y="2027160"/>
            <a:ext cx="5596200" cy="573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075CB3-475B-4172-AD33-E8B60D85A79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55962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453D5D-31EC-4490-9553-C67DCACA57D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53313E-FA2E-45C1-84D6-9728D0AD5CC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FFD82D-F07C-4AE8-9C5A-3C0A758AF0F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10680" y="347400"/>
            <a:ext cx="5596200" cy="6711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6D45F5-D41C-4C38-9393-FC16BC7519C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106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EC50FF-67E4-496A-96D2-8EB3C6E2A0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1780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09A8C9-2E03-4B88-9157-54C06B139C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10680" y="5021640"/>
            <a:ext cx="55962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238CFC-16A5-45A4-8C2D-568885F969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10680" y="2027160"/>
            <a:ext cx="55962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10680" y="8051400"/>
            <a:ext cx="145116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123640" y="8051400"/>
            <a:ext cx="197028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455720" y="8051400"/>
            <a:ext cx="145116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11528B3-D21B-4C7B-8836-5E107676E955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290520" y="762120"/>
          <a:ext cx="5668920" cy="5032080"/>
        </p:xfrm>
        <a:graphic>
          <a:graphicData uri="http://schemas.openxmlformats.org/drawingml/2006/table">
            <a:tbl>
              <a:tblPr/>
              <a:tblGrid>
                <a:gridCol w="1144440"/>
                <a:gridCol w="1132200"/>
                <a:gridCol w="1130040"/>
                <a:gridCol w="1130400"/>
                <a:gridCol w="1131840"/>
              </a:tblGrid>
              <a:tr h="52524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0μM Menadione 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Physiological condition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ean ± SE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7° C, No Gluco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ean ± SE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9° C with Gluco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ean ± SE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9° C, No Gluco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ean ± SE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924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CADD + AO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9.1 ± 9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2.0 ± 9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3.2 ± 7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2.0 ± 5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064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CADD + NAC 0.5mmol/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86.2 ± 15.5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96. 4± 22.4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99.6 ± 8.2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3.4 ± 6.3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4956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CADD + NAC 5mmol/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06.9 ± 15.0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02.4 ± 22.4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11.1 ± 9.5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8.1 ± 6.6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888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924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PT2/MTPD + AO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83.7 ± 30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45.9 ± 25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50.8 ± 18.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02.0 ± 22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632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PT2/MTPD + NAC 0.5mmol/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73.7 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± 25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02.6 ± 35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57.1 ± 7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42.6 ± 8.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100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PT2/MTPD + NAC 5mmol/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18.9 ± 28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41.1± 35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74.1 ± 12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49.9 ± 9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744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888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CADD + AO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60.3 ± 11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21.8 ± 28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25.0 ± 2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14.5 ± 2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100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CADD + NAC 0.5mmol/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18.0 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± 14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20.0 ± 32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09.5 ± 8.0^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78.5 ± 4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4920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CADD + NAC 5mmol/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54.3 ± 19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24.5 ± 36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14.3 ± 7.3^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88.8 ± 1.5^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924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888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ontrols + AO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50.0 ± 9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85.5 ± 3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7.1 ± 1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5.9 ± 1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668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ontrols + NAC 0.5mmol/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81.3 ± 12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13.5 ± 13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97.4 ± 6.9^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0.6 ± 4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064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ontrols + NAC 5mmol/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 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99.7 ± 13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 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26.7 ± 13.4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 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98.0 ± 6.6^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 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1.0 ± 5.0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Rectangle 1"/>
          <p:cNvSpPr/>
          <p:nvPr/>
        </p:nvSpPr>
        <p:spPr>
          <a:xfrm>
            <a:off x="0" y="227880"/>
            <a:ext cx="6218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Calibri"/>
              </a:rPr>
              <a:t>    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Calibri"/>
              </a:rPr>
              <a:t>Table S8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Calibri"/>
              </a:rPr>
              <a:t>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1"/>
          <p:cNvSpPr/>
          <p:nvPr/>
        </p:nvSpPr>
        <p:spPr>
          <a:xfrm>
            <a:off x="0" y="6022080"/>
            <a:ext cx="6218280" cy="76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Calibri"/>
              </a:rPr>
              <a:t>Effect of N-acetyl-cysteine (NAC, 0.5 and 5 mmol/L) intervention on menadione toxicity in each FAO disorder and control lines under variable conditions, compared to AO. A Bonferroni analyis was performed after a logarithmic transformation, to compare each cell line with intervention with AO, and either NAC 0.5 or 5 mmol/L. 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Calibri"/>
              </a:rPr>
              <a:t>^ p&lt;0.05 *p&lt;0.01** p&lt;0.001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0" y="6019920"/>
            <a:ext cx="18432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11T22:39:26Z</dcterms:created>
  <dc:creator>keith cunningham</dc:creator>
  <dc:description/>
  <dc:language>en-US</dc:language>
  <cp:lastModifiedBy>Ingrid Tein</cp:lastModifiedBy>
  <cp:lastPrinted>2011-01-27T01:12:00Z</cp:lastPrinted>
  <dcterms:modified xsi:type="dcterms:W3CDTF">2011-02-25T22:52:56Z</dcterms:modified>
  <cp:revision>33</cp:revision>
  <dc:subject/>
  <dc:title>Slide 1</dc:title>
</cp:coreProperties>
</file>